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0722C-45B0-4066-8002-416C7E2026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D545ED-2BDB-40B1-A44F-59B93614A1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3AFA9-7475-4607-BC82-C86271BE97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193E9-A26B-406D-87D0-4401A0A74A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BC7D5-D345-4EB5-8924-3CCD9FA8FB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695E4-7A45-47E8-AC24-74C67C972C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DA5AE-AFA1-4D29-9354-D0DDBF57DF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141C69-CB5D-4656-878B-FF001D241B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90C322-C4CA-4838-85F8-9855D3D342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1C04A-A712-4C7A-B75A-FCF4114529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6F73F-7E42-4098-9677-CB28E0E17E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21B97-1373-42F9-A0FF-457E266A93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33CFB0-06B3-4F1D-9C3B-96DCC348449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hylogeny of maize and sorghum LTR retrotransposon famili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2322360"/>
            <a:ext cx="4800600" cy="22431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Y Jiao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4 (2017) doi:10.1038/nature2297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6-07T11:56:20Z</dcterms:created>
  <dc:creator>ravikumar.n</dc:creator>
  <dc:description/>
  <dc:language>en-US</dc:language>
  <cp:lastModifiedBy>ravikumar.n</cp:lastModifiedBy>
  <dcterms:modified xsi:type="dcterms:W3CDTF">2017-06-07T11:56:24Z</dcterms:modified>
  <cp:revision>1</cp:revision>
  <dc:subject/>
  <dc:title>Phylogeny of maize and sorghum LTR retrotransposon families</dc:title>
</cp:coreProperties>
</file>